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  <p:sldId id="262" r:id="rId5"/>
    <p:sldId id="263" r:id="rId6"/>
    <p:sldId id="264" r:id="rId7"/>
    <p:sldId id="265" r:id="rId8"/>
    <p:sldId id="266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4" autoAdjust="0"/>
    <p:restoredTop sz="94660"/>
  </p:normalViewPr>
  <p:slideViewPr>
    <p:cSldViewPr snapToGrid="0">
      <p:cViewPr varScale="1">
        <p:scale>
          <a:sx n="44" d="100"/>
          <a:sy n="44" d="100"/>
        </p:scale>
        <p:origin x="40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7435FC-19FE-DE91-12B7-076F0C678C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822C8F1-1349-5D76-A844-90ECC866D5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A41EE5-CDBE-987C-1855-38184E763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67F7C2-034B-9456-FED1-617A2C915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3CE945-E509-E434-5679-4069F613E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527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DCDF3A-7F66-4A32-81DA-861827C90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B8359A0-3457-8F6C-3E63-E6A571EF12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0BD3CF-68D3-FE80-940B-D822D6C5D2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1307C9-EEED-2EB9-75A6-46D81DE98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4E2E48-D0B2-5F38-EC65-36DD0B767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902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DB242C4-B027-2505-6998-8CFF9DC75D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BC047A6-FFB9-0B17-F382-681878F3ED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806AB54-1783-35E0-F593-BBE86E15C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23041C-AB26-CE4F-F047-8E45C1588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798B8A-FB96-5A5D-EDD0-6D6B5EEB8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9335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0C2594-A776-E964-ED03-41234911C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575C4E1-C558-06FA-266F-86A730D4AE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AF0102-8DA5-A60D-9C48-842FB34C1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14D432-B13B-E0A2-5B48-DB9810188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C322D1-3A52-B69B-2D98-4F561A34B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5265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7DFDA6-6BCC-1060-6D54-883FF6DA6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2E2172C-F862-B4AD-8286-128AFFAA35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79A230-30F7-5F5E-69FD-A5E28F9C6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DD20E6-EDCD-96B9-DA20-669072C40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9D9A52-0A92-2840-DDCE-EC4905D00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3158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7BB0D8-6B52-F37B-3258-3A6505B569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F2AF74E-42FE-B5F8-8C00-DC77B07A94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3EB4914-61CE-B798-6D69-ADC17A146F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27936BD-603A-EAA1-E203-36E9CAF6B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DA969B-B55D-0BC9-779E-6C44D33D9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8093D9A-8B8C-A6A0-25D2-2338BC928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8063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5A6C82-E636-232B-971F-28A69FF36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C7FCD7C-0199-6924-EF48-DFAF76E633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8446C44-F996-C4FF-65CE-A5A4354F36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FC7E97E-5670-54A2-13C3-8C43E8E5E7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586A525-514A-8F80-7D39-3D82BD187E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0DBB66E-85AE-2F41-26BC-F21A1849F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70BEEB0-3594-A3C2-6D88-1E6131C4C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4001F5A-8A2F-CF65-CB43-2D5A14A6E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4962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7F181F-5C68-50C1-3ACB-54BBEFB3BF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CD2C4CA-CEAD-AF3A-F21F-D094F717E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723B96D-BAD0-4F05-C59F-58CD38D41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8CA2A4C-0527-9584-DC52-61A5FEE83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3408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0241755-A1AF-3F5B-09B7-B1CC49F4E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437238A-20A4-FCA0-7731-005F2F47D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0147960-302A-A7C5-4D23-08EC03CBE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5753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367DD8-6A01-F8DC-F7C3-91B8CDD405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54563D-0CFA-B7FD-0F56-F66142F88D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D845449-B14D-FA48-B239-8BBB0CBDAD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041511B-F500-0165-B051-8969E0236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EFD721F-614D-5BA5-81E8-8325D867D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D1EF6FB-DE15-3ADA-5E2C-707CE2C83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0118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3E6C14-908C-1714-9476-5A5F52D95F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ED34191-3E64-BF07-3D97-CC1405A83F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A9E3DCA-5879-90C9-D7B9-276DE24E94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4F818E1-951F-0B91-670B-5E1D41778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E7CA13-DE77-6E29-827B-5DD8036E0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1AC14B1-FC73-6495-6090-CF1C8EC7A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561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800A594-F84C-552A-EEC9-D3F4B4CB2E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1AC3010-3B72-07B4-3A14-9F4D119C79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69E705-1EAA-9448-B62D-1095BC41B7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A681DA-5AE8-4EB0-93E1-F3D80B011855}" type="datetimeFigureOut">
              <a:rPr lang="zh-CN" altLang="en-US" smtClean="0"/>
              <a:t>2024/6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540A0C-2637-13D0-93A2-71CB6F7AE6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3F5899-300E-5F47-C304-75BE89BAEB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288363-940A-44A4-82DE-021909D403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8955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690EBA2-FD6C-55D5-E4F5-D728D8B56391}"/>
              </a:ext>
            </a:extLst>
          </p:cNvPr>
          <p:cNvSpPr txBox="1"/>
          <p:nvPr/>
        </p:nvSpPr>
        <p:spPr>
          <a:xfrm>
            <a:off x="4368434" y="5339361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s143384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 descr="图表, 散点图&#10;&#10;描述已自动生成">
            <a:extLst>
              <a:ext uri="{FF2B5EF4-FFF2-40B4-BE49-F238E27FC236}">
                <a16:creationId xmlns:a16="http://schemas.microsoft.com/office/drawing/2014/main" id="{FBD00670-93E2-621F-4ACB-28B6FECFA3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75" y="1330853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6496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CAE1D937-5292-2F82-BC83-D83CA281A459}"/>
              </a:ext>
            </a:extLst>
          </p:cNvPr>
          <p:cNvSpPr txBox="1"/>
          <p:nvPr/>
        </p:nvSpPr>
        <p:spPr>
          <a:xfrm>
            <a:off x="4655092" y="5679398"/>
            <a:ext cx="288181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rs919642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图表, 散点图&#10;&#10;描述已自动生成">
            <a:extLst>
              <a:ext uri="{FF2B5EF4-FFF2-40B4-BE49-F238E27FC236}">
                <a16:creationId xmlns:a16="http://schemas.microsoft.com/office/drawing/2014/main" id="{1CA4042C-E959-BDA1-D992-111DDFF474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8384" y="455453"/>
            <a:ext cx="6235232" cy="470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98492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D3071B4-0E4B-F757-AD66-E92FE8BE607E}"/>
              </a:ext>
            </a:extLst>
          </p:cNvPr>
          <p:cNvSpPr txBox="1"/>
          <p:nvPr/>
        </p:nvSpPr>
        <p:spPr>
          <a:xfrm>
            <a:off x="4368432" y="5525379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s56076919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 descr="图表, 散点图&#10;&#10;描述已自动生成">
            <a:extLst>
              <a:ext uri="{FF2B5EF4-FFF2-40B4-BE49-F238E27FC236}">
                <a16:creationId xmlns:a16="http://schemas.microsoft.com/office/drawing/2014/main" id="{FBFC6E53-99B3-0AA8-DEFC-B62003F04A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4600" y="418277"/>
            <a:ext cx="5322794" cy="4901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97229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7A4DF1B-5662-064F-0CA3-DA49D1F70764}"/>
              </a:ext>
            </a:extLst>
          </p:cNvPr>
          <p:cNvSpPr txBox="1"/>
          <p:nvPr/>
        </p:nvSpPr>
        <p:spPr>
          <a:xfrm>
            <a:off x="4368434" y="5251226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s34148285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 descr="图表, 散点图&#10;&#10;描述已自动生成">
            <a:extLst>
              <a:ext uri="{FF2B5EF4-FFF2-40B4-BE49-F238E27FC236}">
                <a16:creationId xmlns:a16="http://schemas.microsoft.com/office/drawing/2014/main" id="{C3323787-2080-29F0-BC91-437DD17B37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0474" y="551543"/>
            <a:ext cx="6451052" cy="443585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68A34C1-E169-48B9-C39C-98AC53018599}"/>
              </a:ext>
            </a:extLst>
          </p:cNvPr>
          <p:cNvSpPr txBox="1"/>
          <p:nvPr/>
        </p:nvSpPr>
        <p:spPr>
          <a:xfrm>
            <a:off x="4236755" y="816694"/>
            <a:ext cx="3294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0" i="0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ain type(s) experienced in last month: Knee pain</a:t>
            </a:r>
            <a:endParaRPr lang="zh-CN" altLang="en-US" sz="1100" dirty="0">
              <a:latin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56482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7A4DF1B-5662-064F-0CA3-DA49D1F70764}"/>
              </a:ext>
            </a:extLst>
          </p:cNvPr>
          <p:cNvSpPr txBox="1"/>
          <p:nvPr/>
        </p:nvSpPr>
        <p:spPr>
          <a:xfrm>
            <a:off x="4368434" y="5251226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s3892354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9F00896D-AE94-6D05-0A9F-B2FFCC1D1F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1" y="1391626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09624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7A4DF1B-5662-064F-0CA3-DA49D1F70764}"/>
              </a:ext>
            </a:extLst>
          </p:cNvPr>
          <p:cNvSpPr txBox="1"/>
          <p:nvPr/>
        </p:nvSpPr>
        <p:spPr>
          <a:xfrm>
            <a:off x="4368434" y="5251226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s687878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图形用户界面, 文本&#10;&#10;描述已自动生成">
            <a:extLst>
              <a:ext uri="{FF2B5EF4-FFF2-40B4-BE49-F238E27FC236}">
                <a16:creationId xmlns:a16="http://schemas.microsoft.com/office/drawing/2014/main" id="{0D39B3CA-1A5E-B21A-DAE8-6AF1FE9D8A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970" y="840082"/>
            <a:ext cx="10478060" cy="39351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1391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7A4DF1B-5662-064F-0CA3-DA49D1F70764}"/>
              </a:ext>
            </a:extLst>
          </p:cNvPr>
          <p:cNvSpPr txBox="1"/>
          <p:nvPr/>
        </p:nvSpPr>
        <p:spPr>
          <a:xfrm>
            <a:off x="4368434" y="5251226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s687878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F907EB17-9D5C-F41B-9051-DA8EB49C6509}"/>
              </a:ext>
            </a:extLst>
          </p:cNvPr>
          <p:cNvGrpSpPr/>
          <p:nvPr/>
        </p:nvGrpSpPr>
        <p:grpSpPr>
          <a:xfrm>
            <a:off x="2699515" y="194198"/>
            <a:ext cx="6050713" cy="4888430"/>
            <a:chOff x="2699515" y="194198"/>
            <a:chExt cx="6050713" cy="4888430"/>
          </a:xfrm>
        </p:grpSpPr>
        <p:pic>
          <p:nvPicPr>
            <p:cNvPr id="6" name="图片 5" descr="图表, 散点图&#10;&#10;描述已自动生成">
              <a:extLst>
                <a:ext uri="{FF2B5EF4-FFF2-40B4-BE49-F238E27FC236}">
                  <a16:creationId xmlns:a16="http://schemas.microsoft.com/office/drawing/2014/main" id="{DF724C1C-7459-0A66-5F81-BFA31144DC0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41769" y="194198"/>
              <a:ext cx="5308459" cy="4888430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900C499-0DC0-25F4-78AA-13DF670EFE5E}"/>
                </a:ext>
              </a:extLst>
            </p:cNvPr>
            <p:cNvSpPr txBox="1"/>
            <p:nvPr/>
          </p:nvSpPr>
          <p:spPr>
            <a:xfrm>
              <a:off x="4775200" y="507999"/>
              <a:ext cx="23647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zh-CN" sz="1100" b="0" i="0" dirty="0">
                  <a:solidFill>
                    <a:srgbClr val="333333"/>
                  </a:solidFill>
                  <a:effectLst/>
                  <a:highlight>
                    <a:srgbClr val="FFFFFF"/>
                  </a:highlight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Reticulocyte count (two-way meta)</a:t>
              </a:r>
              <a:endParaRPr lang="zh-CN" altLang="en-US" sz="1100" dirty="0">
                <a:latin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8B7DCC48-424B-B337-A827-1DE00F56E24D}"/>
                </a:ext>
              </a:extLst>
            </p:cNvPr>
            <p:cNvSpPr txBox="1"/>
            <p:nvPr/>
          </p:nvSpPr>
          <p:spPr>
            <a:xfrm>
              <a:off x="2699515" y="715409"/>
              <a:ext cx="343395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0" i="0" dirty="0">
                  <a:solidFill>
                    <a:srgbClr val="333333"/>
                  </a:solidFill>
                  <a:effectLst/>
                  <a:highlight>
                    <a:srgbClr val="FFFFFF"/>
                  </a:highlight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High light scatter reticulocyte count (two-way meta)</a:t>
              </a:r>
              <a:endParaRPr lang="zh-CN" altLang="en-US" sz="1100" dirty="0">
                <a:latin typeface="Tahoma" panose="020B0604030504040204" pitchFamily="34" charset="0"/>
                <a:cs typeface="Tahoma" panose="020B060403050404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09412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7A4DF1B-5662-064F-0CA3-DA49D1F70764}"/>
              </a:ext>
            </a:extLst>
          </p:cNvPr>
          <p:cNvSpPr txBox="1"/>
          <p:nvPr/>
        </p:nvSpPr>
        <p:spPr>
          <a:xfrm>
            <a:off x="4368434" y="5251226"/>
            <a:ext cx="34551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PheWAS of </a:t>
            </a:r>
            <a:r>
              <a:rPr lang="en-US" altLang="zh-CN" sz="2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s145408100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9A80C2CA-47DA-64E4-9A1C-80B4F142D75E}"/>
              </a:ext>
            </a:extLst>
          </p:cNvPr>
          <p:cNvGrpSpPr/>
          <p:nvPr/>
        </p:nvGrpSpPr>
        <p:grpSpPr>
          <a:xfrm>
            <a:off x="3118754" y="494841"/>
            <a:ext cx="5954491" cy="4492561"/>
            <a:chOff x="3118754" y="494841"/>
            <a:chExt cx="5954491" cy="4492561"/>
          </a:xfrm>
        </p:grpSpPr>
        <p:pic>
          <p:nvPicPr>
            <p:cNvPr id="6" name="图片 5" descr="图表, 散点图&#10;&#10;描述已自动生成">
              <a:extLst>
                <a:ext uri="{FF2B5EF4-FFF2-40B4-BE49-F238E27FC236}">
                  <a16:creationId xmlns:a16="http://schemas.microsoft.com/office/drawing/2014/main" id="{FE8AB348-B9ED-0106-2C75-7E82DE2F31E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18754" y="494841"/>
              <a:ext cx="5954491" cy="4492561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C99CD3A-F666-68FA-0588-CD823F4F126B}"/>
                </a:ext>
              </a:extLst>
            </p:cNvPr>
            <p:cNvSpPr txBox="1"/>
            <p:nvPr/>
          </p:nvSpPr>
          <p:spPr>
            <a:xfrm>
              <a:off x="4107176" y="776515"/>
              <a:ext cx="329930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0" dirty="0">
                  <a:solidFill>
                    <a:srgbClr val="333333"/>
                  </a:solidFill>
                  <a:effectLst/>
                  <a:highlight>
                    <a:srgbClr val="FFFFFF"/>
                  </a:highlight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Pain type(s) experienced in last month: Knee pain</a:t>
              </a:r>
              <a:endParaRPr lang="zh-CN" altLang="en-US" sz="1100" dirty="0">
                <a:latin typeface="Tahoma" panose="020B0604030504040204" pitchFamily="34" charset="0"/>
                <a:cs typeface="Tahoma" panose="020B060403050404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08626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</TotalTime>
  <Words>63</Words>
  <Application>Microsoft Office PowerPoint</Application>
  <PresentationFormat>宽屏</PresentationFormat>
  <Paragraphs>12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等线</vt:lpstr>
      <vt:lpstr>等线 Light</vt:lpstr>
      <vt:lpstr>Arial</vt:lpstr>
      <vt:lpstr>Tahoma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Eureka Li</dc:creator>
  <cp:lastModifiedBy>Eureka Li</cp:lastModifiedBy>
  <cp:revision>7</cp:revision>
  <dcterms:created xsi:type="dcterms:W3CDTF">2024-05-09T05:44:57Z</dcterms:created>
  <dcterms:modified xsi:type="dcterms:W3CDTF">2024-06-01T07:53:25Z</dcterms:modified>
</cp:coreProperties>
</file>